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notesMasterIdLst>
    <p:notesMasterId r:id="rId4"/>
  </p:notesMasterIdLst>
  <p:sldIdLst>
    <p:sldId id="621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4" d="100"/>
          <a:sy n="64" d="100"/>
        </p:scale>
        <p:origin x="1292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763469-3DC0-4FB5-B251-E07AD9BE0819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6C6BCD-5D7F-4E7B-BA92-B48A24D66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4448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2994F78-CC85-47BE-8395-9068CB32DD3F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1584889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840BC-473F-49E5-84D5-33D48E90CF80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EE1A5-2A9C-45CA-B9CF-F4D36B640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0467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840BC-473F-49E5-84D5-33D48E90CF80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EE1A5-2A9C-45CA-B9CF-F4D36B640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87238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840BC-473F-49E5-84D5-33D48E90CF80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EE1A5-2A9C-45CA-B9CF-F4D36B640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58001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BC09B-054B-41FC-9B74-B58B6A5D28BF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CE4E9-A485-43DC-B16E-6BA92B445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755630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BC09B-054B-41FC-9B74-B58B6A5D28BF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CE4E9-A485-43DC-B16E-6BA92B445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72308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41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6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BC09B-054B-41FC-9B74-B58B6A5D28BF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CE4E9-A485-43DC-B16E-6BA92B445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022959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BC09B-054B-41FC-9B74-B58B6A5D28BF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CE4E9-A485-43DC-B16E-6BA92B445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275682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8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BC09B-054B-41FC-9B74-B58B6A5D28BF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CE4E9-A485-43DC-B16E-6BA92B445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823466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BC09B-054B-41FC-9B74-B58B6A5D28BF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CE4E9-A485-43DC-B16E-6BA92B445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83900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BC09B-054B-41FC-9B74-B58B6A5D28BF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CE4E9-A485-43DC-B16E-6BA92B445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59579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8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BC09B-054B-41FC-9B74-B58B6A5D28BF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CE4E9-A485-43DC-B16E-6BA92B445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54173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840BC-473F-49E5-84D5-33D48E90CF80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EE1A5-2A9C-45CA-B9CF-F4D36B640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052159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8"/>
            <a:ext cx="4629150" cy="4873625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BC09B-054B-41FC-9B74-B58B6A5D28BF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CE4E9-A485-43DC-B16E-6BA92B445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113506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BC09B-054B-41FC-9B74-B58B6A5D28BF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CE4E9-A485-43DC-B16E-6BA92B445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80553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BC09B-054B-41FC-9B74-B58B6A5D28BF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CE4E9-A485-43DC-B16E-6BA92B445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4496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840BC-473F-49E5-84D5-33D48E90CF80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EE1A5-2A9C-45CA-B9CF-F4D36B640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349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840BC-473F-49E5-84D5-33D48E90CF80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EE1A5-2A9C-45CA-B9CF-F4D36B640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3407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840BC-473F-49E5-84D5-33D48E90CF80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EE1A5-2A9C-45CA-B9CF-F4D36B640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83225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840BC-473F-49E5-84D5-33D48E90CF80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EE1A5-2A9C-45CA-B9CF-F4D36B640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25886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840BC-473F-49E5-84D5-33D48E90CF80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EE1A5-2A9C-45CA-B9CF-F4D36B640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84652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840BC-473F-49E5-84D5-33D48E90CF80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EE1A5-2A9C-45CA-B9CF-F4D36B640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26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840BC-473F-49E5-84D5-33D48E90CF80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EE1A5-2A9C-45CA-B9CF-F4D36B640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0875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9840BC-473F-49E5-84D5-33D48E90CF80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3EE1A5-2A9C-45CA-B9CF-F4D36B640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76295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8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DBC09B-054B-41FC-9B74-B58B6A5D28BF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3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2CE4E9-A485-43DC-B16E-6BA92B445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463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8.xml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extBox 71">
            <a:extLst>
              <a:ext uri="{FF2B5EF4-FFF2-40B4-BE49-F238E27FC236}">
                <a16:creationId xmlns:a16="http://schemas.microsoft.com/office/drawing/2014/main" id="{CC6E4762-2271-4D36-B73D-35383C8560DA}"/>
              </a:ext>
            </a:extLst>
          </p:cNvPr>
          <p:cNvSpPr txBox="1"/>
          <p:nvPr/>
        </p:nvSpPr>
        <p:spPr>
          <a:xfrm>
            <a:off x="4338685" y="-1199813"/>
            <a:ext cx="580907" cy="2237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51435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427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ONFIDENTIAL 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79BFB896-AFC6-41EE-8701-76D73D817857}"/>
              </a:ext>
            </a:extLst>
          </p:cNvPr>
          <p:cNvSpPr txBox="1"/>
          <p:nvPr/>
        </p:nvSpPr>
        <p:spPr>
          <a:xfrm>
            <a:off x="3645448" y="-1190553"/>
            <a:ext cx="264188" cy="2456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51435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32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3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2B4AAD7C-861B-4C0C-A061-4A87587FDC7E}"/>
              </a:ext>
            </a:extLst>
          </p:cNvPr>
          <p:cNvGrpSpPr/>
          <p:nvPr/>
        </p:nvGrpSpPr>
        <p:grpSpPr>
          <a:xfrm>
            <a:off x="1778950" y="2313005"/>
            <a:ext cx="5563287" cy="2213388"/>
            <a:chOff x="1778950" y="2313005"/>
            <a:chExt cx="5563287" cy="2213388"/>
          </a:xfrm>
        </p:grpSpPr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2B256216-03FF-432F-870C-F5CD34C0D23B}"/>
                </a:ext>
              </a:extLst>
            </p:cNvPr>
            <p:cNvGrpSpPr/>
            <p:nvPr/>
          </p:nvGrpSpPr>
          <p:grpSpPr>
            <a:xfrm>
              <a:off x="1778950" y="2331607"/>
              <a:ext cx="1871330" cy="2194786"/>
              <a:chOff x="3561375" y="939759"/>
              <a:chExt cx="2495106" cy="2926381"/>
            </a:xfrm>
          </p:grpSpPr>
          <p:pic>
            <p:nvPicPr>
              <p:cNvPr id="30" name="Picture 29">
                <a:extLst>
                  <a:ext uri="{FF2B5EF4-FFF2-40B4-BE49-F238E27FC236}">
                    <a16:creationId xmlns:a16="http://schemas.microsoft.com/office/drawing/2014/main" id="{451D144B-15F3-489C-9AE9-4D3B7524BC63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67023" y="939759"/>
                <a:ext cx="2395728" cy="2926381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4C2435F4-0E99-4D6E-BE58-06E5D91B4491}"/>
                  </a:ext>
                </a:extLst>
              </p:cNvPr>
              <p:cNvSpPr txBox="1"/>
              <p:nvPr/>
            </p:nvSpPr>
            <p:spPr>
              <a:xfrm>
                <a:off x="4756552" y="1854528"/>
                <a:ext cx="1299929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22062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25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KRAS G12D-NE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C8F73408-E9B6-48A3-A1F5-08880B18FC4F}"/>
                  </a:ext>
                </a:extLst>
              </p:cNvPr>
              <p:cNvSpPr txBox="1"/>
              <p:nvPr/>
            </p:nvSpPr>
            <p:spPr>
              <a:xfrm>
                <a:off x="5062283" y="3156223"/>
                <a:ext cx="701474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22062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25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IB-21G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0A90CAAC-F10B-4247-8ECF-CD5529A5EFDF}"/>
                  </a:ext>
                </a:extLst>
              </p:cNvPr>
              <p:cNvSpPr txBox="1"/>
              <p:nvPr/>
            </p:nvSpPr>
            <p:spPr>
              <a:xfrm>
                <a:off x="4868136" y="3303184"/>
                <a:ext cx="1051998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22062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25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KD = 641nM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ECFB184A-D728-41A5-9FC6-C0A7CDEB0B9C}"/>
                  </a:ext>
                </a:extLst>
              </p:cNvPr>
              <p:cNvSpPr txBox="1"/>
              <p:nvPr/>
            </p:nvSpPr>
            <p:spPr>
              <a:xfrm>
                <a:off x="3561375" y="947835"/>
                <a:ext cx="321029" cy="2847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22062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88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a</a:t>
                </a:r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34D87E8B-DECB-49D4-9EF1-D2AEBC83533D}"/>
                </a:ext>
              </a:extLst>
            </p:cNvPr>
            <p:cNvGrpSpPr/>
            <p:nvPr/>
          </p:nvGrpSpPr>
          <p:grpSpPr>
            <a:xfrm>
              <a:off x="5496562" y="2331607"/>
              <a:ext cx="1845675" cy="2194560"/>
              <a:chOff x="8518191" y="945002"/>
              <a:chExt cx="2477810" cy="2926080"/>
            </a:xfrm>
          </p:grpSpPr>
          <p:pic>
            <p:nvPicPr>
              <p:cNvPr id="39" name="Picture 38">
                <a:extLst>
                  <a:ext uri="{FF2B5EF4-FFF2-40B4-BE49-F238E27FC236}">
                    <a16:creationId xmlns:a16="http://schemas.microsoft.com/office/drawing/2014/main" id="{E914FF6E-7244-4234-B7D9-11183B79BA35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534653" y="945002"/>
                <a:ext cx="2395728" cy="292608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85B714D4-B45C-4769-ACAB-EEE96C775710}"/>
                  </a:ext>
                </a:extLst>
              </p:cNvPr>
              <p:cNvSpPr txBox="1"/>
              <p:nvPr/>
            </p:nvSpPr>
            <p:spPr>
              <a:xfrm>
                <a:off x="9687139" y="1855130"/>
                <a:ext cx="1308862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22062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25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KRAS G12D-NE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38ECF9F5-7CD3-45B4-8EFD-3DEF65963536}"/>
                  </a:ext>
                </a:extLst>
              </p:cNvPr>
              <p:cNvSpPr txBox="1"/>
              <p:nvPr/>
            </p:nvSpPr>
            <p:spPr>
              <a:xfrm>
                <a:off x="10041347" y="3181881"/>
                <a:ext cx="738575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22062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25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IIA-15D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0E176F8D-6118-4860-BAA9-86D5E8A80057}"/>
                  </a:ext>
                </a:extLst>
              </p:cNvPr>
              <p:cNvSpPr txBox="1"/>
              <p:nvPr/>
            </p:nvSpPr>
            <p:spPr>
              <a:xfrm>
                <a:off x="9634742" y="3336894"/>
                <a:ext cx="1257213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22062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25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KD = 11,600nM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9E22AEE7-A6D0-4694-85F4-8795F770AD35}"/>
                  </a:ext>
                </a:extLst>
              </p:cNvPr>
              <p:cNvSpPr txBox="1"/>
              <p:nvPr/>
            </p:nvSpPr>
            <p:spPr>
              <a:xfrm>
                <a:off x="8518191" y="957743"/>
                <a:ext cx="323235" cy="2847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22062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88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c</a:t>
                </a:r>
              </a:p>
            </p:txBody>
          </p:sp>
        </p:grp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3B047424-FD13-43B5-A520-B1FF72D06F4E}"/>
                </a:ext>
              </a:extLst>
            </p:cNvPr>
            <p:cNvGrpSpPr/>
            <p:nvPr/>
          </p:nvGrpSpPr>
          <p:grpSpPr>
            <a:xfrm>
              <a:off x="3631455" y="2313005"/>
              <a:ext cx="1877088" cy="2194560"/>
              <a:chOff x="6011663" y="937955"/>
              <a:chExt cx="2543088" cy="2959333"/>
            </a:xfrm>
          </p:grpSpPr>
          <p:pic>
            <p:nvPicPr>
              <p:cNvPr id="37" name="Picture 36">
                <a:extLst>
                  <a:ext uri="{FF2B5EF4-FFF2-40B4-BE49-F238E27FC236}">
                    <a16:creationId xmlns:a16="http://schemas.microsoft.com/office/drawing/2014/main" id="{47679F5A-5F25-4B71-B761-58FAE55378A1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050242" y="971208"/>
                <a:ext cx="2395728" cy="292608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89CB894A-D8B9-4108-A168-CEFE89735A24}"/>
                  </a:ext>
                </a:extLst>
              </p:cNvPr>
              <p:cNvSpPr txBox="1"/>
              <p:nvPr/>
            </p:nvSpPr>
            <p:spPr>
              <a:xfrm>
                <a:off x="7233888" y="1888205"/>
                <a:ext cx="1320863" cy="295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22062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25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KRAS G12D-NE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99923D19-EBF4-4737-8D02-C522DE997F89}"/>
                  </a:ext>
                </a:extLst>
              </p:cNvPr>
              <p:cNvSpPr txBox="1"/>
              <p:nvPr/>
            </p:nvSpPr>
            <p:spPr>
              <a:xfrm>
                <a:off x="7198764" y="3328073"/>
                <a:ext cx="1188385" cy="295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22062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25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KD = 4,810nM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37360483-A146-4941-BAF6-584B27CD8657}"/>
                  </a:ext>
                </a:extLst>
              </p:cNvPr>
              <p:cNvSpPr txBox="1"/>
              <p:nvPr/>
            </p:nvSpPr>
            <p:spPr>
              <a:xfrm>
                <a:off x="7569207" y="3189349"/>
                <a:ext cx="682367" cy="295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22062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25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IB-21J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5059EEA2-A430-4D13-91AB-771880A3ED30}"/>
                  </a:ext>
                </a:extLst>
              </p:cNvPr>
              <p:cNvSpPr txBox="1"/>
              <p:nvPr/>
            </p:nvSpPr>
            <p:spPr>
              <a:xfrm>
                <a:off x="6011663" y="937955"/>
                <a:ext cx="334886" cy="2880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22062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88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b</a:t>
                </a:r>
              </a:p>
            </p:txBody>
          </p:sp>
        </p:grpSp>
      </p:grpSp>
      <p:sp>
        <p:nvSpPr>
          <p:cNvPr id="23" name="Rectangle 22">
            <a:extLst>
              <a:ext uri="{FF2B5EF4-FFF2-40B4-BE49-F238E27FC236}">
                <a16:creationId xmlns:a16="http://schemas.microsoft.com/office/drawing/2014/main" id="{FD293AFA-4743-44EE-8783-8BCAE531B54B}"/>
              </a:ext>
            </a:extLst>
          </p:cNvPr>
          <p:cNvSpPr/>
          <p:nvPr/>
        </p:nvSpPr>
        <p:spPr>
          <a:xfrm>
            <a:off x="532430" y="1240825"/>
            <a:ext cx="234391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ure S1</a:t>
            </a: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7027019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2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8</Words>
  <Application>Microsoft Office PowerPoint</Application>
  <PresentationFormat>On-screen Show (4:3)</PresentationFormat>
  <Paragraphs>1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2_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id Sebti</dc:creator>
  <cp:lastModifiedBy>Said Sebti</cp:lastModifiedBy>
  <cp:revision>1</cp:revision>
  <dcterms:created xsi:type="dcterms:W3CDTF">2023-10-30T19:37:38Z</dcterms:created>
  <dcterms:modified xsi:type="dcterms:W3CDTF">2023-10-30T19:38:07Z</dcterms:modified>
</cp:coreProperties>
</file>